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33"/>
  </p:normalViewPr>
  <p:slideViewPr>
    <p:cSldViewPr snapToGrid="0" snapToObjects="1">
      <p:cViewPr varScale="1">
        <p:scale>
          <a:sx n="114" d="100"/>
          <a:sy n="114" d="100"/>
        </p:scale>
        <p:origin x="15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Central%20and%20peripheral%20parts%20of%20leaf%20sheath\CP%20and%20PP%20rtpcr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CC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2:$E$3</c:f>
                <c:numCache>
                  <c:formatCode>General</c:formatCode>
                  <c:ptCount val="2"/>
                  <c:pt idx="0">
                    <c:v>4.0598602220747217E-2</c:v>
                  </c:pt>
                  <c:pt idx="1">
                    <c:v>0.29056409193278987</c:v>
                  </c:pt>
                </c:numCache>
              </c:numRef>
            </c:plus>
            <c:minus>
              <c:numRef>
                <c:f>average_SE!$E$2:$E$3</c:f>
                <c:numCache>
                  <c:formatCode>General</c:formatCode>
                  <c:ptCount val="2"/>
                  <c:pt idx="0">
                    <c:v>4.0598602220747217E-2</c:v>
                  </c:pt>
                  <c:pt idx="1">
                    <c:v>0.290564091932789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2:$D$3</c:f>
              <c:numCache>
                <c:formatCode>0.00</c:formatCode>
                <c:ptCount val="2"/>
                <c:pt idx="0">
                  <c:v>1.9327138956719379</c:v>
                </c:pt>
                <c:pt idx="1">
                  <c:v>2.64877989702644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5F-DE4D-812A-5407F2F3C4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0531903"/>
        <c:axId val="570695695"/>
      </c:barChart>
      <c:catAx>
        <c:axId val="5705319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0695695"/>
        <c:crosses val="autoZero"/>
        <c:auto val="1"/>
        <c:lblAlgn val="ctr"/>
        <c:lblOffset val="100"/>
        <c:noMultiLvlLbl val="0"/>
      </c:catAx>
      <c:valAx>
        <c:axId val="570695695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05319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LC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14:$E$15</c:f>
                <c:numCache>
                  <c:formatCode>General</c:formatCode>
                  <c:ptCount val="2"/>
                  <c:pt idx="0">
                    <c:v>0.10344366894532502</c:v>
                  </c:pt>
                  <c:pt idx="1">
                    <c:v>0.17935159381019192</c:v>
                  </c:pt>
                </c:numCache>
              </c:numRef>
            </c:plus>
            <c:minus>
              <c:numRef>
                <c:f>average_SE!$E$14:$E$15</c:f>
                <c:numCache>
                  <c:formatCode>General</c:formatCode>
                  <c:ptCount val="2"/>
                  <c:pt idx="0">
                    <c:v>0.10344366894532502</c:v>
                  </c:pt>
                  <c:pt idx="1">
                    <c:v>0.179351593810191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14:$D$15</c:f>
              <c:numCache>
                <c:formatCode>0.00</c:formatCode>
                <c:ptCount val="2"/>
                <c:pt idx="0">
                  <c:v>1.7756645307369208</c:v>
                </c:pt>
                <c:pt idx="1">
                  <c:v>1.36928237976470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DE-7B4F-8C07-58F5A546DE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7482495"/>
        <c:axId val="578175551"/>
      </c:barChart>
      <c:catAx>
        <c:axId val="5774824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8175551"/>
        <c:crosses val="autoZero"/>
        <c:auto val="1"/>
        <c:lblAlgn val="ctr"/>
        <c:lblOffset val="100"/>
        <c:noMultiLvlLbl val="0"/>
      </c:catAx>
      <c:valAx>
        <c:axId val="578175551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74824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LC6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1273908265338531"/>
          <c:y val="0.30662802463781913"/>
          <c:w val="0.70334903998126175"/>
          <c:h val="0.4908404993847596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22:$E$23</c:f>
                <c:numCache>
                  <c:formatCode>General</c:formatCode>
                  <c:ptCount val="2"/>
                  <c:pt idx="0">
                    <c:v>0.34285239408488855</c:v>
                  </c:pt>
                  <c:pt idx="1">
                    <c:v>0.15274573190215393</c:v>
                  </c:pt>
                </c:numCache>
              </c:numRef>
            </c:plus>
            <c:minus>
              <c:numRef>
                <c:f>average_SE!$E$22:$E$23</c:f>
                <c:numCache>
                  <c:formatCode>General</c:formatCode>
                  <c:ptCount val="2"/>
                  <c:pt idx="0">
                    <c:v>0.34285239408488855</c:v>
                  </c:pt>
                  <c:pt idx="1">
                    <c:v>0.152745731902153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22:$D$23</c:f>
              <c:numCache>
                <c:formatCode>0.00</c:formatCode>
                <c:ptCount val="2"/>
                <c:pt idx="0">
                  <c:v>2.3566137924569346</c:v>
                </c:pt>
                <c:pt idx="1">
                  <c:v>1.77936911692206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73-6646-893A-7DBC5FFC71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4448895"/>
        <c:axId val="574779679"/>
      </c:barChart>
      <c:catAx>
        <c:axId val="5144488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4779679"/>
        <c:crosses val="autoZero"/>
        <c:auto val="1"/>
        <c:lblAlgn val="ctr"/>
        <c:lblOffset val="100"/>
        <c:noMultiLvlLbl val="0"/>
      </c:catAx>
      <c:valAx>
        <c:axId val="574779679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144488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SLAH7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130:$E$131</c:f>
                <c:numCache>
                  <c:formatCode>General</c:formatCode>
                  <c:ptCount val="2"/>
                  <c:pt idx="0">
                    <c:v>6.4531550031071874E-2</c:v>
                  </c:pt>
                  <c:pt idx="1">
                    <c:v>0.38936391110017504</c:v>
                  </c:pt>
                </c:numCache>
              </c:numRef>
            </c:plus>
            <c:minus>
              <c:numRef>
                <c:f>average_SE!$E$130:$E$131</c:f>
                <c:numCache>
                  <c:formatCode>General</c:formatCode>
                  <c:ptCount val="2"/>
                  <c:pt idx="0">
                    <c:v>6.4531550031071874E-2</c:v>
                  </c:pt>
                  <c:pt idx="1">
                    <c:v>0.389363911100175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130:$D$131</c:f>
              <c:numCache>
                <c:formatCode>0.00</c:formatCode>
                <c:ptCount val="2"/>
                <c:pt idx="0">
                  <c:v>0.35888635368011707</c:v>
                </c:pt>
                <c:pt idx="1">
                  <c:v>2.43959018181171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CB-9B4A-95EC-277F87AD40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1046127"/>
        <c:axId val="627588207"/>
      </c:barChart>
      <c:catAx>
        <c:axId val="6210461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7588207"/>
        <c:crosses val="autoZero"/>
        <c:auto val="1"/>
        <c:lblAlgn val="ctr"/>
        <c:lblOffset val="100"/>
        <c:noMultiLvlLbl val="0"/>
      </c:catAx>
      <c:valAx>
        <c:axId val="627588207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104612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LC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10:$E$11</c:f>
                <c:numCache>
                  <c:formatCode>General</c:formatCode>
                  <c:ptCount val="2"/>
                  <c:pt idx="0">
                    <c:v>0.14074835791105361</c:v>
                  </c:pt>
                  <c:pt idx="1">
                    <c:v>0.21776583522913023</c:v>
                  </c:pt>
                </c:numCache>
              </c:numRef>
            </c:plus>
            <c:minus>
              <c:numRef>
                <c:f>average_SE!$E$10:$E$11</c:f>
                <c:numCache>
                  <c:formatCode>General</c:formatCode>
                  <c:ptCount val="2"/>
                  <c:pt idx="0">
                    <c:v>0.14074835791105361</c:v>
                  </c:pt>
                  <c:pt idx="1">
                    <c:v>0.217765835229130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10:$D$11</c:f>
              <c:numCache>
                <c:formatCode>0.00</c:formatCode>
                <c:ptCount val="2"/>
                <c:pt idx="0">
                  <c:v>0.72072540726047463</c:v>
                </c:pt>
                <c:pt idx="1">
                  <c:v>0.94969754610687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C6-A54D-926B-1F961CFFF3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868975"/>
        <c:axId val="576011231"/>
      </c:barChart>
      <c:catAx>
        <c:axId val="575868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6011231"/>
        <c:crosses val="autoZero"/>
        <c:auto val="1"/>
        <c:lblAlgn val="ctr"/>
        <c:lblOffset val="100"/>
        <c:noMultiLvlLbl val="0"/>
      </c:catAx>
      <c:valAx>
        <c:axId val="576011231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868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NPF2;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74:$E$75</c:f>
                <c:numCache>
                  <c:formatCode>General</c:formatCode>
                  <c:ptCount val="2"/>
                  <c:pt idx="0">
                    <c:v>0.42592171886056379</c:v>
                  </c:pt>
                  <c:pt idx="1">
                    <c:v>0.67728426013902066</c:v>
                  </c:pt>
                </c:numCache>
              </c:numRef>
            </c:plus>
            <c:minus>
              <c:numRef>
                <c:f>average_SE!$E$74:$E$75</c:f>
                <c:numCache>
                  <c:formatCode>General</c:formatCode>
                  <c:ptCount val="2"/>
                  <c:pt idx="0">
                    <c:v>0.42592171886056379</c:v>
                  </c:pt>
                  <c:pt idx="1">
                    <c:v>0.677284260139020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74:$D$75</c:f>
              <c:numCache>
                <c:formatCode>0.00</c:formatCode>
                <c:ptCount val="2"/>
                <c:pt idx="0">
                  <c:v>3.4672471434574441</c:v>
                </c:pt>
                <c:pt idx="1">
                  <c:v>3.24505231952857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4A-024A-A8F8-95BFA52E89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4229247"/>
        <c:axId val="575794975"/>
      </c:barChart>
      <c:catAx>
        <c:axId val="6242292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94975"/>
        <c:crosses val="autoZero"/>
        <c:auto val="1"/>
        <c:lblAlgn val="ctr"/>
        <c:lblOffset val="100"/>
        <c:noMultiLvlLbl val="0"/>
      </c:catAx>
      <c:valAx>
        <c:axId val="575794975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42292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LC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18:$E$19</c:f>
                <c:numCache>
                  <c:formatCode>General</c:formatCode>
                  <c:ptCount val="2"/>
                  <c:pt idx="0">
                    <c:v>0.40784254473566245</c:v>
                  </c:pt>
                  <c:pt idx="1">
                    <c:v>0.30626443369875955</c:v>
                  </c:pt>
                </c:numCache>
              </c:numRef>
            </c:plus>
            <c:minus>
              <c:numRef>
                <c:f>average_SE!$E$18:$E$19</c:f>
                <c:numCache>
                  <c:formatCode>General</c:formatCode>
                  <c:ptCount val="2"/>
                  <c:pt idx="0">
                    <c:v>0.40784254473566245</c:v>
                  </c:pt>
                  <c:pt idx="1">
                    <c:v>0.306264433698759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18:$D$19</c:f>
              <c:numCache>
                <c:formatCode>0.00</c:formatCode>
                <c:ptCount val="2"/>
                <c:pt idx="0">
                  <c:v>1.6473097792037175</c:v>
                </c:pt>
                <c:pt idx="1">
                  <c:v>2.22547717404214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42-2440-9C9A-C06C1F32FB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3630431"/>
        <c:axId val="596084559"/>
      </c:barChart>
      <c:catAx>
        <c:axId val="5736304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6084559"/>
        <c:crosses val="autoZero"/>
        <c:auto val="1"/>
        <c:lblAlgn val="ctr"/>
        <c:lblOffset val="100"/>
        <c:noMultiLvlLbl val="0"/>
      </c:catAx>
      <c:valAx>
        <c:axId val="596084559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363043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SLAH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X$22:$X$23</c:f>
                <c:numCache>
                  <c:formatCode>General</c:formatCode>
                  <c:ptCount val="2"/>
                  <c:pt idx="0">
                    <c:v>1.2497581543820566E-4</c:v>
                  </c:pt>
                  <c:pt idx="1">
                    <c:v>2.1444053047665942E-2</c:v>
                  </c:pt>
                </c:numCache>
              </c:numRef>
            </c:plus>
            <c:minus>
              <c:numRef>
                <c:f>Sheet1!$X$22:$X$23</c:f>
                <c:numCache>
                  <c:formatCode>General</c:formatCode>
                  <c:ptCount val="2"/>
                  <c:pt idx="0">
                    <c:v>1.2497581543820566E-4</c:v>
                  </c:pt>
                  <c:pt idx="1">
                    <c:v>2.144405304766594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7:$B$18</c:f>
              <c:strCache>
                <c:ptCount val="2"/>
                <c:pt idx="0">
                  <c:v>Central </c:v>
                </c:pt>
                <c:pt idx="1">
                  <c:v>Peripheral</c:v>
                </c:pt>
              </c:strCache>
            </c:strRef>
          </c:cat>
          <c:val>
            <c:numRef>
              <c:f>Sheet1!$X$17:$X$18</c:f>
              <c:numCache>
                <c:formatCode>0.00E+00</c:formatCode>
                <c:ptCount val="2"/>
                <c:pt idx="0">
                  <c:v>7.8793333333333337E-4</c:v>
                </c:pt>
                <c:pt idx="1">
                  <c:v>7.358666666666667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E4-3F45-B6C5-16AF968A59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2598495"/>
        <c:axId val="381953119"/>
      </c:barChart>
      <c:catAx>
        <c:axId val="3825984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81953119"/>
        <c:crosses val="autoZero"/>
        <c:auto val="1"/>
        <c:lblAlgn val="ctr"/>
        <c:lblOffset val="100"/>
        <c:noMultiLvlLbl val="0"/>
      </c:catAx>
      <c:valAx>
        <c:axId val="381953119"/>
        <c:scaling>
          <c:orientation val="minMax"/>
        </c:scaling>
        <c:delete val="0"/>
        <c:axPos val="l"/>
        <c:numFmt formatCode="#,##0.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825984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98272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81498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30004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404534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08085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67679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93613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97917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47044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862176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01947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54199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CE36611B-7A56-C34F-8D1F-548E9CFED8D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905348528"/>
              </p:ext>
            </p:extLst>
          </p:nvPr>
        </p:nvGraphicFramePr>
        <p:xfrm>
          <a:off x="2876640" y="589569"/>
          <a:ext cx="1858010" cy="1354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348AC7BE-EFE9-F949-943D-AFFA5BF5DF4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33223998"/>
              </p:ext>
            </p:extLst>
          </p:nvPr>
        </p:nvGraphicFramePr>
        <p:xfrm>
          <a:off x="1021805" y="1943389"/>
          <a:ext cx="1854835" cy="1354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64A1C53-B89D-1B49-9519-36B4FEE3437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114937246"/>
              </p:ext>
            </p:extLst>
          </p:nvPr>
        </p:nvGraphicFramePr>
        <p:xfrm>
          <a:off x="4732110" y="1944024"/>
          <a:ext cx="1854835" cy="1354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CCE4B469-4644-3943-B7CC-0E49BD0CF20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92194140"/>
              </p:ext>
            </p:extLst>
          </p:nvPr>
        </p:nvGraphicFramePr>
        <p:xfrm>
          <a:off x="2893150" y="3294669"/>
          <a:ext cx="1864360" cy="1354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50A0DC7C-8E6B-1545-8DF2-0C0035F60FB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160587531"/>
              </p:ext>
            </p:extLst>
          </p:nvPr>
        </p:nvGraphicFramePr>
        <p:xfrm>
          <a:off x="4735920" y="590204"/>
          <a:ext cx="1854835" cy="1354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91E253F8-8999-FF4C-942F-6CE7D439730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02989607"/>
              </p:ext>
            </p:extLst>
          </p:nvPr>
        </p:nvGraphicFramePr>
        <p:xfrm>
          <a:off x="1023075" y="594649"/>
          <a:ext cx="1854835" cy="1354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F3C87153-088D-A443-8391-075DD3FAFA6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12381350"/>
              </p:ext>
            </p:extLst>
          </p:nvPr>
        </p:nvGraphicFramePr>
        <p:xfrm>
          <a:off x="2879180" y="1944024"/>
          <a:ext cx="1854835" cy="1354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E21DD294-D766-6948-94CC-018F2F29A0D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45573045"/>
              </p:ext>
            </p:extLst>
          </p:nvPr>
        </p:nvGraphicFramePr>
        <p:xfrm>
          <a:off x="1022440" y="3298479"/>
          <a:ext cx="1864360" cy="1354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2" name="Text Box 16">
            <a:extLst>
              <a:ext uri="{FF2B5EF4-FFF2-40B4-BE49-F238E27FC236}">
                <a16:creationId xmlns:a16="http://schemas.microsoft.com/office/drawing/2014/main" id="{7BB244B0-5A5B-F94B-AD82-3FD5D5BD64F6}"/>
              </a:ext>
            </a:extLst>
          </p:cNvPr>
          <p:cNvSpPr txBox="1"/>
          <p:nvPr/>
        </p:nvSpPr>
        <p:spPr>
          <a:xfrm>
            <a:off x="1023075" y="590204"/>
            <a:ext cx="29337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a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13" name="Text Box 17">
            <a:extLst>
              <a:ext uri="{FF2B5EF4-FFF2-40B4-BE49-F238E27FC236}">
                <a16:creationId xmlns:a16="http://schemas.microsoft.com/office/drawing/2014/main" id="{A5FC6F71-B7C0-D448-916B-389C64597466}"/>
              </a:ext>
            </a:extLst>
          </p:cNvPr>
          <p:cNvSpPr txBox="1"/>
          <p:nvPr/>
        </p:nvSpPr>
        <p:spPr>
          <a:xfrm>
            <a:off x="2873465" y="589569"/>
            <a:ext cx="33655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b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14" name="Text Box 18">
            <a:extLst>
              <a:ext uri="{FF2B5EF4-FFF2-40B4-BE49-F238E27FC236}">
                <a16:creationId xmlns:a16="http://schemas.microsoft.com/office/drawing/2014/main" id="{18ABDCFC-3ED2-2745-B2BC-71507B8A2127}"/>
              </a:ext>
            </a:extLst>
          </p:cNvPr>
          <p:cNvSpPr txBox="1"/>
          <p:nvPr/>
        </p:nvSpPr>
        <p:spPr>
          <a:xfrm>
            <a:off x="4740365" y="588299"/>
            <a:ext cx="29337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c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15" name="Text Box 19">
            <a:extLst>
              <a:ext uri="{FF2B5EF4-FFF2-40B4-BE49-F238E27FC236}">
                <a16:creationId xmlns:a16="http://schemas.microsoft.com/office/drawing/2014/main" id="{1C86F79F-2A54-354E-A7CF-D29FB36070F3}"/>
              </a:ext>
            </a:extLst>
          </p:cNvPr>
          <p:cNvSpPr txBox="1"/>
          <p:nvPr/>
        </p:nvSpPr>
        <p:spPr>
          <a:xfrm>
            <a:off x="1024345" y="1944024"/>
            <a:ext cx="29845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d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16" name="Text Box 20">
            <a:extLst>
              <a:ext uri="{FF2B5EF4-FFF2-40B4-BE49-F238E27FC236}">
                <a16:creationId xmlns:a16="http://schemas.microsoft.com/office/drawing/2014/main" id="{E359ACC0-28CA-3D44-AF02-E12844551C96}"/>
              </a:ext>
            </a:extLst>
          </p:cNvPr>
          <p:cNvSpPr txBox="1"/>
          <p:nvPr/>
        </p:nvSpPr>
        <p:spPr>
          <a:xfrm>
            <a:off x="2875370" y="1939579"/>
            <a:ext cx="29337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e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17" name="Text Box 14">
            <a:extLst>
              <a:ext uri="{FF2B5EF4-FFF2-40B4-BE49-F238E27FC236}">
                <a16:creationId xmlns:a16="http://schemas.microsoft.com/office/drawing/2014/main" id="{BF010A29-BD75-174D-A5E3-4E4DF62F00B4}"/>
              </a:ext>
            </a:extLst>
          </p:cNvPr>
          <p:cNvSpPr txBox="1"/>
          <p:nvPr/>
        </p:nvSpPr>
        <p:spPr>
          <a:xfrm>
            <a:off x="4732745" y="1938944"/>
            <a:ext cx="356235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f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18" name="Text Box 15">
            <a:extLst>
              <a:ext uri="{FF2B5EF4-FFF2-40B4-BE49-F238E27FC236}">
                <a16:creationId xmlns:a16="http://schemas.microsoft.com/office/drawing/2014/main" id="{018AD009-DC83-4642-8438-2A3627036400}"/>
              </a:ext>
            </a:extLst>
          </p:cNvPr>
          <p:cNvSpPr txBox="1"/>
          <p:nvPr/>
        </p:nvSpPr>
        <p:spPr>
          <a:xfrm>
            <a:off x="2896325" y="3292764"/>
            <a:ext cx="336550" cy="31305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h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19" name="Text Box 21">
            <a:extLst>
              <a:ext uri="{FF2B5EF4-FFF2-40B4-BE49-F238E27FC236}">
                <a16:creationId xmlns:a16="http://schemas.microsoft.com/office/drawing/2014/main" id="{FA1818AC-8F76-A449-AB3D-BCBA6EF2DDDA}"/>
              </a:ext>
            </a:extLst>
          </p:cNvPr>
          <p:cNvSpPr txBox="1"/>
          <p:nvPr/>
        </p:nvSpPr>
        <p:spPr>
          <a:xfrm>
            <a:off x="1033235" y="3303559"/>
            <a:ext cx="32766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g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0" name="Text Box 30">
            <a:extLst>
              <a:ext uri="{FF2B5EF4-FFF2-40B4-BE49-F238E27FC236}">
                <a16:creationId xmlns:a16="http://schemas.microsoft.com/office/drawing/2014/main" id="{FBAEBAA7-D1C7-F140-BA2F-DC4BE68B32ED}"/>
              </a:ext>
            </a:extLst>
          </p:cNvPr>
          <p:cNvSpPr txBox="1"/>
          <p:nvPr/>
        </p:nvSpPr>
        <p:spPr>
          <a:xfrm rot="16200000">
            <a:off x="35332" y="2398367"/>
            <a:ext cx="1876425" cy="32385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Relative expression level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1" name="Text Box 10">
            <a:extLst>
              <a:ext uri="{FF2B5EF4-FFF2-40B4-BE49-F238E27FC236}">
                <a16:creationId xmlns:a16="http://schemas.microsoft.com/office/drawing/2014/main" id="{740EF3B7-2BEF-324A-832E-78A1EE2024FD}"/>
              </a:ext>
            </a:extLst>
          </p:cNvPr>
          <p:cNvSpPr txBox="1"/>
          <p:nvPr/>
        </p:nvSpPr>
        <p:spPr>
          <a:xfrm>
            <a:off x="4163150" y="3585499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2" name="Text Box 9">
            <a:extLst>
              <a:ext uri="{FF2B5EF4-FFF2-40B4-BE49-F238E27FC236}">
                <a16:creationId xmlns:a16="http://schemas.microsoft.com/office/drawing/2014/main" id="{2E7254AC-8E3C-4440-8F9D-EB1DCB4F0CB0}"/>
              </a:ext>
            </a:extLst>
          </p:cNvPr>
          <p:cNvSpPr txBox="1"/>
          <p:nvPr/>
        </p:nvSpPr>
        <p:spPr>
          <a:xfrm>
            <a:off x="2290535" y="3594389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900940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</TotalTime>
  <Words>29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in Neang</dc:creator>
  <cp:lastModifiedBy>三屋 史朗</cp:lastModifiedBy>
  <cp:revision>11</cp:revision>
  <dcterms:created xsi:type="dcterms:W3CDTF">2020-05-19T13:06:08Z</dcterms:created>
  <dcterms:modified xsi:type="dcterms:W3CDTF">2020-06-02T09:46:36Z</dcterms:modified>
</cp:coreProperties>
</file>